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9" d="100"/>
          <a:sy n="69" d="100"/>
        </p:scale>
        <p:origin x="56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D2EDF-C231-4CA0-BADE-788A02078783}" type="datetimeFigureOut">
              <a:rPr lang="en-US" smtClean="0"/>
              <a:t>4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DCC04-27C9-4F37-9CEC-FA89C27593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37162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D2EDF-C231-4CA0-BADE-788A02078783}" type="datetimeFigureOut">
              <a:rPr lang="en-US" smtClean="0"/>
              <a:t>4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DCC04-27C9-4F37-9CEC-FA89C27593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7918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D2EDF-C231-4CA0-BADE-788A02078783}" type="datetimeFigureOut">
              <a:rPr lang="en-US" smtClean="0"/>
              <a:t>4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DCC04-27C9-4F37-9CEC-FA89C27593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46738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D2EDF-C231-4CA0-BADE-788A02078783}" type="datetimeFigureOut">
              <a:rPr lang="en-US" smtClean="0"/>
              <a:t>4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DCC04-27C9-4F37-9CEC-FA89C27593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24650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D2EDF-C231-4CA0-BADE-788A02078783}" type="datetimeFigureOut">
              <a:rPr lang="en-US" smtClean="0"/>
              <a:t>4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DCC04-27C9-4F37-9CEC-FA89C27593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35556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D2EDF-C231-4CA0-BADE-788A02078783}" type="datetimeFigureOut">
              <a:rPr lang="en-US" smtClean="0"/>
              <a:t>4/1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DCC04-27C9-4F37-9CEC-FA89C27593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28926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D2EDF-C231-4CA0-BADE-788A02078783}" type="datetimeFigureOut">
              <a:rPr lang="en-US" smtClean="0"/>
              <a:t>4/15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DCC04-27C9-4F37-9CEC-FA89C27593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20902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D2EDF-C231-4CA0-BADE-788A02078783}" type="datetimeFigureOut">
              <a:rPr lang="en-US" smtClean="0"/>
              <a:t>4/15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DCC04-27C9-4F37-9CEC-FA89C27593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46661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D2EDF-C231-4CA0-BADE-788A02078783}" type="datetimeFigureOut">
              <a:rPr lang="en-US" smtClean="0"/>
              <a:t>4/15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DCC04-27C9-4F37-9CEC-FA89C27593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80298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D2EDF-C231-4CA0-BADE-788A02078783}" type="datetimeFigureOut">
              <a:rPr lang="en-US" smtClean="0"/>
              <a:t>4/1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DCC04-27C9-4F37-9CEC-FA89C27593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35843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D2EDF-C231-4CA0-BADE-788A02078783}" type="datetimeFigureOut">
              <a:rPr lang="en-US" smtClean="0"/>
              <a:t>4/1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DCC04-27C9-4F37-9CEC-FA89C27593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83253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6D2EDF-C231-4CA0-BADE-788A02078783}" type="datetimeFigureOut">
              <a:rPr lang="en-US" smtClean="0"/>
              <a:t>4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FDCC04-27C9-4F37-9CEC-FA89C27593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56073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Afbeelding 15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06404" y="250248"/>
            <a:ext cx="5760720" cy="537845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475673" y="5628698"/>
            <a:ext cx="11222182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b="1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</a:t>
            </a:r>
            <a:r>
              <a:rPr lang="en-US" sz="1200" b="1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.</a:t>
            </a:r>
            <a:r>
              <a:rPr lang="en-US" sz="12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iagnostic PCR of the </a:t>
            </a:r>
            <a:r>
              <a:rPr lang="en-US" sz="1200" i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arA</a:t>
            </a:r>
            <a:r>
              <a:rPr lang="en-US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ORF in </a:t>
            </a:r>
            <a:r>
              <a:rPr lang="en-US" sz="12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A234.1 </a:t>
            </a:r>
            <a:r>
              <a:rPr lang="en-US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d the </a:t>
            </a:r>
            <a:r>
              <a:rPr lang="en-US" sz="1200" i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arA</a:t>
            </a:r>
            <a:r>
              <a:rPr lang="en-US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utant to confirm successful deletion of the gene. Primers were used to amplify a roughly 900 </a:t>
            </a:r>
            <a:r>
              <a:rPr lang="en-US" sz="1200" i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p</a:t>
            </a:r>
            <a:r>
              <a:rPr lang="en-US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fragments of the 5’ and 3’ region of the locus. </a:t>
            </a:r>
            <a:r>
              <a:rPr lang="en-US" sz="1200" b="1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1) </a:t>
            </a:r>
            <a:r>
              <a:rPr lang="en-US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sing the four diagnostic primers designed for the </a:t>
            </a:r>
            <a:r>
              <a:rPr lang="en-US" sz="1200" i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arA</a:t>
            </a:r>
            <a:r>
              <a:rPr lang="en-US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ORF, only unsuccessful knockouts and </a:t>
            </a:r>
            <a:r>
              <a:rPr lang="en-US" sz="1200" i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ildtype</a:t>
            </a:r>
            <a:r>
              <a:rPr lang="en-US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N402 </a:t>
            </a:r>
            <a:r>
              <a:rPr lang="en-US" sz="1200" i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DNA</a:t>
            </a:r>
            <a:r>
              <a:rPr lang="en-US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ill generate product. </a:t>
            </a:r>
            <a:r>
              <a:rPr lang="en-US" sz="1200" b="1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2)</a:t>
            </a:r>
            <a:r>
              <a:rPr lang="en-US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Using the four diagnostic primers designed for the selection marker ORF, only successful knockouts will generate product. </a:t>
            </a:r>
            <a:r>
              <a:rPr lang="en-US" sz="1200" b="1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3)</a:t>
            </a:r>
            <a:r>
              <a:rPr lang="en-US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Diagnostic PCR results were examined utilizing gel electrophoresis and proper knockout of the </a:t>
            </a:r>
            <a:r>
              <a:rPr lang="en-US" sz="1200" i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arA</a:t>
            </a:r>
            <a:r>
              <a:rPr lang="en-US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ORF was confirmed.</a:t>
            </a:r>
            <a:endParaRPr lang="nl-NL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675641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4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ISS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thur</dc:creator>
  <cp:lastModifiedBy>Arthur</cp:lastModifiedBy>
  <cp:revision>3</cp:revision>
  <dcterms:created xsi:type="dcterms:W3CDTF">2022-03-28T10:38:06Z</dcterms:created>
  <dcterms:modified xsi:type="dcterms:W3CDTF">2022-04-15T11:56:50Z</dcterms:modified>
</cp:coreProperties>
</file>